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7" r:id="rId2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3110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8901" autoAdjust="0"/>
  </p:normalViewPr>
  <p:slideViewPr>
    <p:cSldViewPr>
      <p:cViewPr>
        <p:scale>
          <a:sx n="100" d="100"/>
          <a:sy n="100" d="100"/>
        </p:scale>
        <p:origin x="-1747" y="2491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62" d="100"/>
          <a:sy n="62" d="100"/>
        </p:scale>
        <p:origin x="-2850" y="-72"/>
      </p:cViewPr>
      <p:guideLst>
        <p:guide orient="horz" pos="3110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529AB-F4AD-4839-8590-580ED4C58164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2B58D-F4F5-41E0-9E7B-6BBCC6D20DA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41673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59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608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23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408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2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95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65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8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27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88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45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D6353-391B-4E73-95A6-B55E8B568226}" type="datetimeFigureOut">
              <a:rPr lang="en-GB" smtClean="0"/>
              <a:pPr/>
              <a:t>20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0F3A1-CEF2-4826-99C2-26EB5D284A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65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0648" y="200472"/>
            <a:ext cx="3816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6632" y="56051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276872" y="56051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052" name="Group 2051"/>
          <p:cNvGrpSpPr>
            <a:grpSpLocks noChangeAspect="1"/>
          </p:cNvGrpSpPr>
          <p:nvPr/>
        </p:nvGrpSpPr>
        <p:grpSpPr>
          <a:xfrm>
            <a:off x="2269646" y="1424608"/>
            <a:ext cx="2786760" cy="1318902"/>
            <a:chOff x="161574" y="982106"/>
            <a:chExt cx="3483451" cy="1648629"/>
          </a:xfrm>
        </p:grpSpPr>
        <p:cxnSp>
          <p:nvCxnSpPr>
            <p:cNvPr id="6" name="Straight Connector 5"/>
            <p:cNvCxnSpPr/>
            <p:nvPr/>
          </p:nvCxnSpPr>
          <p:spPr>
            <a:xfrm>
              <a:off x="260649" y="1352599"/>
              <a:ext cx="136815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260649" y="1784648"/>
              <a:ext cx="136815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1628800" y="1352599"/>
              <a:ext cx="1008112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636913" y="1352599"/>
              <a:ext cx="100811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1628800" y="1784648"/>
              <a:ext cx="100811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V="1">
              <a:off x="1628800" y="1362175"/>
              <a:ext cx="0" cy="422472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 flipV="1">
              <a:off x="1628800" y="1362175"/>
              <a:ext cx="1008112" cy="422472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332656" y="1424608"/>
              <a:ext cx="288033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H="1">
              <a:off x="692696" y="1424608"/>
              <a:ext cx="288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332656" y="1712639"/>
              <a:ext cx="288033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H="1">
              <a:off x="692696" y="1712639"/>
              <a:ext cx="288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1124744" y="1856655"/>
              <a:ext cx="288033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>
              <a:off x="1916833" y="1865039"/>
              <a:ext cx="288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 flipH="1">
              <a:off x="1484784" y="1856655"/>
              <a:ext cx="288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1124744" y="1280591"/>
              <a:ext cx="288033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H="1">
              <a:off x="2852968" y="1280591"/>
              <a:ext cx="288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9" name="TextBox 2048"/>
            <p:cNvSpPr txBox="1"/>
            <p:nvPr/>
          </p:nvSpPr>
          <p:spPr>
            <a:xfrm>
              <a:off x="980736" y="982106"/>
              <a:ext cx="576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23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780937" y="982106"/>
              <a:ext cx="576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24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844808" y="1856656"/>
              <a:ext cx="576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24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980696" y="1856656"/>
              <a:ext cx="576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23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340751" y="1856656"/>
              <a:ext cx="720065" cy="500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obe 25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60616" y="1450299"/>
              <a:ext cx="576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7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20672" y="1442093"/>
              <a:ext cx="576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r8</a:t>
              </a:r>
            </a:p>
          </p:txBody>
        </p:sp>
        <p:sp>
          <p:nvSpPr>
            <p:cNvPr id="2051" name="TextBox 2050"/>
            <p:cNvSpPr txBox="1"/>
            <p:nvPr/>
          </p:nvSpPr>
          <p:spPr>
            <a:xfrm>
              <a:off x="161574" y="2322957"/>
              <a:ext cx="909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Z1-RD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65076" y="2322958"/>
              <a:ext cx="19718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Z1-F 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junction</a:t>
              </a:r>
            </a:p>
          </p:txBody>
        </p:sp>
      </p:grpSp>
      <p:sp>
        <p:nvSpPr>
          <p:cNvPr id="67" name="TextBox 56"/>
          <p:cNvSpPr txBox="1"/>
          <p:nvPr/>
        </p:nvSpPr>
        <p:spPr>
          <a:xfrm>
            <a:off x="116632" y="288451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6" name="TextBox 56"/>
          <p:cNvSpPr txBox="1"/>
          <p:nvPr/>
        </p:nvSpPr>
        <p:spPr>
          <a:xfrm>
            <a:off x="4005064" y="2864768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6" name="Groep 25">
            <a:extLst>
              <a:ext uri="{FF2B5EF4-FFF2-40B4-BE49-F238E27FC236}">
                <a16:creationId xmlns:a16="http://schemas.microsoft.com/office/drawing/2014/main" xmlns="" id="{EA006420-7863-44AB-ADC1-084BAE4BE642}"/>
              </a:ext>
            </a:extLst>
          </p:cNvPr>
          <p:cNvGrpSpPr/>
          <p:nvPr/>
        </p:nvGrpSpPr>
        <p:grpSpPr>
          <a:xfrm>
            <a:off x="5013176" y="603681"/>
            <a:ext cx="1800202" cy="2405103"/>
            <a:chOff x="5186697" y="560512"/>
            <a:chExt cx="1800202" cy="2405103"/>
          </a:xfrm>
        </p:grpSpPr>
        <p:grpSp>
          <p:nvGrpSpPr>
            <p:cNvPr id="15" name="Groep 14"/>
            <p:cNvGrpSpPr/>
            <p:nvPr/>
          </p:nvGrpSpPr>
          <p:grpSpPr>
            <a:xfrm>
              <a:off x="5186697" y="560512"/>
              <a:ext cx="1770695" cy="2405103"/>
              <a:chOff x="44624" y="1795879"/>
              <a:chExt cx="1770695" cy="2405103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44624" y="1795879"/>
                <a:ext cx="1656186" cy="2405103"/>
                <a:chOff x="44624" y="1795879"/>
                <a:chExt cx="1656186" cy="2405103"/>
              </a:xfrm>
            </p:grpSpPr>
            <p:pic>
              <p:nvPicPr>
                <p:cNvPr id="8" name="Picture 3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0651" y="2144968"/>
                  <a:ext cx="1440159" cy="180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" name="TextBox 1"/>
                <p:cNvSpPr txBox="1"/>
                <p:nvPr/>
              </p:nvSpPr>
              <p:spPr>
                <a:xfrm>
                  <a:off x="304546" y="3800872"/>
                  <a:ext cx="862701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ull-length plasmid</a:t>
                  </a:r>
                </a:p>
              </p:txBody>
            </p:sp>
            <p:pic>
              <p:nvPicPr>
                <p:cNvPr id="3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9485" t="8773" r="17869" b="85591"/>
                <a:stretch/>
              </p:blipFill>
              <p:spPr bwMode="auto">
                <a:xfrm>
                  <a:off x="692695" y="1968734"/>
                  <a:ext cx="958193" cy="32810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8" name="TextBox 57"/>
                <p:cNvSpPr txBox="1"/>
                <p:nvPr/>
              </p:nvSpPr>
              <p:spPr>
                <a:xfrm>
                  <a:off x="44624" y="1795879"/>
                  <a:ext cx="432048" cy="22313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Q</a:t>
                  </a:r>
                </a:p>
                <a:p>
                  <a:pPr algn="r"/>
                  <a:endParaRPr lang="en-GB" sz="6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.2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n-GB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  <a:p>
                  <a:pPr algn="r"/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</a:p>
                <a:p>
                  <a:pPr algn="r"/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6</a:t>
                  </a:r>
                </a:p>
                <a:p>
                  <a:pPr algn="r"/>
                  <a:endParaRPr lang="en-GB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</a:p>
                <a:p>
                  <a:pPr algn="r"/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</a:p>
                <a:p>
                  <a:pPr algn="r"/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</p:grpSp>
          <p:sp>
            <p:nvSpPr>
              <p:cNvPr id="59" name="TextBox 58"/>
              <p:cNvSpPr txBox="1"/>
              <p:nvPr/>
            </p:nvSpPr>
            <p:spPr>
              <a:xfrm>
                <a:off x="952618" y="3800872"/>
                <a:ext cx="86270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-variant plasmid</a:t>
                </a:r>
              </a:p>
            </p:txBody>
          </p:sp>
        </p:grpSp>
        <p:sp>
          <p:nvSpPr>
            <p:cNvPr id="88" name="TextBox 122">
              <a:extLst>
                <a:ext uri="{FF2B5EF4-FFF2-40B4-BE49-F238E27FC236}">
                  <a16:creationId xmlns:a16="http://schemas.microsoft.com/office/drawing/2014/main" xmlns="" id="{F553ED88-9886-4F93-AABD-10D9B39D55AD}"/>
                </a:ext>
              </a:extLst>
            </p:cNvPr>
            <p:cNvSpPr txBox="1"/>
            <p:nvPr/>
          </p:nvSpPr>
          <p:spPr>
            <a:xfrm>
              <a:off x="6021288" y="828031"/>
              <a:ext cx="338091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nl-NL" sz="1000" dirty="0" smtClean="0">
                  <a:latin typeface="Arial" pitchFamily="34" charset="0"/>
                  <a:cs typeface="Arial" pitchFamily="34" charset="0"/>
                </a:rPr>
                <a:t>CIZ1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Box 122">
              <a:extLst>
                <a:ext uri="{FF2B5EF4-FFF2-40B4-BE49-F238E27FC236}">
                  <a16:creationId xmlns:a16="http://schemas.microsoft.com/office/drawing/2014/main" xmlns="" id="{9188BE34-9567-4F52-B72E-988E18D2BD12}"/>
                </a:ext>
              </a:extLst>
            </p:cNvPr>
            <p:cNvSpPr txBox="1"/>
            <p:nvPr/>
          </p:nvSpPr>
          <p:spPr>
            <a:xfrm>
              <a:off x="6453336" y="828031"/>
              <a:ext cx="53356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nl-NL" sz="1000" dirty="0" smtClean="0">
                  <a:latin typeface="Arial" pitchFamily="34" charset="0"/>
                  <a:cs typeface="Arial" pitchFamily="34" charset="0"/>
                </a:rPr>
                <a:t>CIZ1-F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290846" y="3100537"/>
            <a:ext cx="3816424" cy="2664296"/>
            <a:chOff x="548680" y="3800871"/>
            <a:chExt cx="3816424" cy="2664296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696" y="4089104"/>
              <a:ext cx="3013326" cy="18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4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53" t="4017" r="12694" b="84908"/>
            <a:stretch/>
          </p:blipFill>
          <p:spPr bwMode="auto">
            <a:xfrm>
              <a:off x="2564904" y="4210283"/>
              <a:ext cx="492026" cy="4381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TextBox 61"/>
            <p:cNvSpPr txBox="1"/>
            <p:nvPr/>
          </p:nvSpPr>
          <p:spPr>
            <a:xfrm>
              <a:off x="548680" y="3800871"/>
              <a:ext cx="432048" cy="2046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Q</a:t>
              </a:r>
            </a:p>
            <a:p>
              <a:pPr algn="r"/>
              <a:endParaRPr lang="en-GB" sz="6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/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/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/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1903595" y="4679600"/>
              <a:ext cx="862701" cy="2708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MCF10</a:t>
              </a:r>
            </a:p>
            <a:p>
              <a:pPr algn="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MRC5</a:t>
              </a:r>
            </a:p>
            <a:p>
              <a:pPr algn="r"/>
              <a:endParaRPr lang="en-GB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FL1</a:t>
              </a:r>
            </a:p>
            <a:p>
              <a:pPr algn="r"/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MCF7</a:t>
              </a:r>
            </a:p>
            <a:p>
              <a:pPr algn="r"/>
              <a:endParaRPr lang="en-GB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BT474</a:t>
              </a:r>
            </a:p>
            <a:p>
              <a:pPr algn="r"/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KBR3</a:t>
              </a:r>
            </a:p>
            <a:p>
              <a:pPr algn="r"/>
              <a:endParaRPr lang="en-GB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MDA231</a:t>
              </a:r>
            </a:p>
            <a:p>
              <a:pPr algn="r"/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727</a:t>
              </a:r>
            </a:p>
            <a:p>
              <a:pPr algn="r"/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J</a:t>
              </a:r>
            </a:p>
            <a:p>
              <a:pPr algn="r"/>
              <a:endParaRPr lang="en-GB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BC5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GB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BC2</a:t>
              </a:r>
            </a:p>
            <a:p>
              <a:pPr algn="r"/>
              <a:endParaRPr lang="en-GB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</a:p>
          </p:txBody>
        </p:sp>
        <p:sp>
          <p:nvSpPr>
            <p:cNvPr id="21" name="Tekstvak 20"/>
            <p:cNvSpPr txBox="1"/>
            <p:nvPr/>
          </p:nvSpPr>
          <p:spPr>
            <a:xfrm>
              <a:off x="2673861" y="4209947"/>
              <a:ext cx="89879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rtlCol="0">
              <a:spAutoFit/>
            </a:bodyPr>
            <a:lstStyle/>
            <a:p>
              <a:r>
                <a:rPr lang="nl-NL" sz="1000" dirty="0"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nl-NL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  <a:endParaRPr lang="nl-NL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kstvak 67"/>
            <p:cNvSpPr txBox="1"/>
            <p:nvPr/>
          </p:nvSpPr>
          <p:spPr>
            <a:xfrm>
              <a:off x="2673861" y="4418747"/>
              <a:ext cx="66193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rtlCol="0">
              <a:spAutoFit/>
            </a:bodyPr>
            <a:lstStyle/>
            <a:p>
              <a:r>
                <a:rPr lang="nl-NL" sz="1000" dirty="0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1628800" y="4089104"/>
              <a:ext cx="0" cy="1511968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32885" y="3978619"/>
              <a:ext cx="732219" cy="18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6" name="TextBox 65"/>
            <p:cNvSpPr txBox="1"/>
            <p:nvPr/>
          </p:nvSpPr>
          <p:spPr>
            <a:xfrm rot="16200000">
              <a:off x="3552808" y="5909313"/>
              <a:ext cx="8627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Means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474264" y="4029482"/>
              <a:ext cx="432048" cy="17235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/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pPr algn="r"/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/>
              <a:endParaRPr lang="en-GB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/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4201376" y="3028529"/>
            <a:ext cx="1747904" cy="2160240"/>
            <a:chOff x="4201376" y="3113858"/>
            <a:chExt cx="1747904" cy="2160240"/>
          </a:xfrm>
        </p:grpSpPr>
        <p:grpSp>
          <p:nvGrpSpPr>
            <p:cNvPr id="30" name="Groep 29">
              <a:extLst>
                <a:ext uri="{FF2B5EF4-FFF2-40B4-BE49-F238E27FC236}">
                  <a16:creationId xmlns:a16="http://schemas.microsoft.com/office/drawing/2014/main" xmlns="" id="{51D9DC3C-40F0-441F-85E0-D2299235B612}"/>
                </a:ext>
              </a:extLst>
            </p:cNvPr>
            <p:cNvGrpSpPr/>
            <p:nvPr/>
          </p:nvGrpSpPr>
          <p:grpSpPr>
            <a:xfrm>
              <a:off x="4201376" y="3113858"/>
              <a:ext cx="1747904" cy="2160240"/>
              <a:chOff x="634530" y="6568537"/>
              <a:chExt cx="1747904" cy="2160240"/>
            </a:xfrm>
          </p:grpSpPr>
          <p:pic>
            <p:nvPicPr>
              <p:cNvPr id="28" name="Afbeelding 27">
                <a:extLst>
                  <a:ext uri="{FF2B5EF4-FFF2-40B4-BE49-F238E27FC236}">
                    <a16:creationId xmlns:a16="http://schemas.microsoft.com/office/drawing/2014/main" xmlns="" id="{023EF5F2-7FDA-4CB1-AA9C-7E76BE1CE6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904692" y="6871793"/>
                <a:ext cx="1410596" cy="1800000"/>
              </a:xfrm>
              <a:prstGeom prst="rect">
                <a:avLst/>
              </a:prstGeom>
            </p:spPr>
          </p:pic>
          <p:sp>
            <p:nvSpPr>
              <p:cNvPr id="73" name="TextBox 127"/>
              <p:cNvSpPr txBox="1"/>
              <p:nvPr/>
            </p:nvSpPr>
            <p:spPr>
              <a:xfrm>
                <a:off x="634530" y="6568537"/>
                <a:ext cx="432048" cy="21082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Q</a:t>
                </a:r>
              </a:p>
              <a:p>
                <a:pPr algn="r"/>
                <a:endParaRPr lang="en-GB" sz="6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.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  <a:p>
                <a:pPr algn="r"/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  <a:p>
                <a:pPr algn="r"/>
                <a:endParaRPr lang="en-GB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  <a:p>
                <a:pPr algn="r"/>
                <a:endParaRPr lang="en-GB" sz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 algn="r"/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74" name="TextBox 130"/>
              <p:cNvSpPr txBox="1"/>
              <p:nvPr/>
            </p:nvSpPr>
            <p:spPr>
              <a:xfrm>
                <a:off x="870266" y="8482556"/>
                <a:ext cx="8591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oestrogen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131"/>
              <p:cNvSpPr txBox="1"/>
              <p:nvPr/>
            </p:nvSpPr>
            <p:spPr>
              <a:xfrm>
                <a:off x="1563508" y="8482556"/>
                <a:ext cx="8189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oestrogen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4649662" y="3401890"/>
              <a:ext cx="969084" cy="707886"/>
              <a:chOff x="2388635" y="6750896"/>
              <a:chExt cx="1011587" cy="775974"/>
            </a:xfrm>
          </p:grpSpPr>
          <p:pic>
            <p:nvPicPr>
              <p:cNvPr id="72" name="Picture 2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485" t="4540" r="38257" b="70970"/>
              <a:stretch/>
            </p:blipFill>
            <p:spPr bwMode="auto">
              <a:xfrm>
                <a:off x="2388635" y="6803295"/>
                <a:ext cx="827795" cy="7048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6" name="Tekstvak 67"/>
              <p:cNvSpPr txBox="1"/>
              <p:nvPr/>
            </p:nvSpPr>
            <p:spPr>
              <a:xfrm>
                <a:off x="2503248" y="6750896"/>
                <a:ext cx="896974" cy="77597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rtlCol="0">
                <a:spAutoFit/>
              </a:bodyPr>
              <a:lstStyle/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Z1 ex11-12</a:t>
                </a:r>
              </a:p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Z1-F</a:t>
                </a:r>
              </a:p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yclin D1</a:t>
                </a:r>
              </a:p>
              <a:p>
                <a:r>
                  <a:rPr lang="nl-NL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nl-NL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7" name="Group 86"/>
          <p:cNvGrpSpPr/>
          <p:nvPr/>
        </p:nvGrpSpPr>
        <p:grpSpPr>
          <a:xfrm>
            <a:off x="-75786" y="1003885"/>
            <a:ext cx="2482298" cy="1716867"/>
            <a:chOff x="264748" y="1177235"/>
            <a:chExt cx="2482298" cy="1716867"/>
          </a:xfrm>
        </p:grpSpPr>
        <p:grpSp>
          <p:nvGrpSpPr>
            <p:cNvPr id="90" name="Group 89"/>
            <p:cNvGrpSpPr/>
            <p:nvPr/>
          </p:nvGrpSpPr>
          <p:grpSpPr>
            <a:xfrm>
              <a:off x="264748" y="1177235"/>
              <a:ext cx="2482298" cy="1716867"/>
              <a:chOff x="1708635" y="2730044"/>
              <a:chExt cx="2482298" cy="1716867"/>
            </a:xfrm>
          </p:grpSpPr>
          <p:pic>
            <p:nvPicPr>
              <p:cNvPr id="105" name="Picture 24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47400" y="2730044"/>
                <a:ext cx="460076" cy="171686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106" name="TextBox 105"/>
              <p:cNvSpPr txBox="1"/>
              <p:nvPr/>
            </p:nvSpPr>
            <p:spPr>
              <a:xfrm>
                <a:off x="1708635" y="3006751"/>
                <a:ext cx="676185" cy="5616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00kb</a:t>
                </a:r>
              </a:p>
              <a:p>
                <a:pPr algn="r"/>
                <a:endParaRPr lang="en-GB" sz="10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GB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0kb</a:t>
                </a:r>
                <a:endParaRPr lang="en-GB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7" name="Straight Connector 106"/>
              <p:cNvCxnSpPr/>
              <p:nvPr/>
            </p:nvCxnSpPr>
            <p:spPr bwMode="auto">
              <a:xfrm>
                <a:off x="2840165" y="3078759"/>
                <a:ext cx="216000" cy="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med" len="med"/>
              </a:ln>
              <a:effectLst/>
            </p:spPr>
          </p:cxnSp>
          <p:cxnSp>
            <p:nvCxnSpPr>
              <p:cNvPr id="108" name="Straight Connector 107"/>
              <p:cNvCxnSpPr/>
              <p:nvPr/>
            </p:nvCxnSpPr>
            <p:spPr bwMode="auto">
              <a:xfrm>
                <a:off x="2840165" y="3382199"/>
                <a:ext cx="216000" cy="0"/>
              </a:xfrm>
              <a:prstGeom prst="line">
                <a:avLst/>
              </a:prstGeom>
              <a:solidFill>
                <a:schemeClr val="accent1"/>
              </a:solidFill>
              <a:ln w="1905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triangle" w="med" len="med"/>
              </a:ln>
              <a:effectLst/>
            </p:spPr>
          </p:cxnSp>
          <p:sp>
            <p:nvSpPr>
              <p:cNvPr id="109" name="TextBox 108"/>
              <p:cNvSpPr txBox="1"/>
              <p:nvPr/>
            </p:nvSpPr>
            <p:spPr>
              <a:xfrm>
                <a:off x="3000679" y="2934743"/>
                <a:ext cx="1190254" cy="7232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ull-length</a:t>
                </a:r>
              </a:p>
              <a:p>
                <a:endParaRPr lang="en-GB" sz="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GB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nl-NL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IZ1-F</a:t>
                </a:r>
                <a:endParaRPr lang="nl-NL" sz="3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nl-NL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IZ1-D (</a:t>
                </a:r>
                <a:r>
                  <a:rPr lang="el-GR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GB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6a-F)</a:t>
                </a:r>
                <a:endParaRPr lang="en-GB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98" name="Straight Connector 97"/>
            <p:cNvCxnSpPr/>
            <p:nvPr/>
          </p:nvCxnSpPr>
          <p:spPr bwMode="auto">
            <a:xfrm>
              <a:off x="1397017" y="1957998"/>
              <a:ext cx="216000" cy="0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</p:cxnSp>
      </p:grpSp>
      <p:sp>
        <p:nvSpPr>
          <p:cNvPr id="110" name="TextBox 109"/>
          <p:cNvSpPr txBox="1"/>
          <p:nvPr/>
        </p:nvSpPr>
        <p:spPr>
          <a:xfrm>
            <a:off x="4869160" y="560512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5457056"/>
            <a:ext cx="6813377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Figure 1. Validation of quantitative RT-PCR tools, </a:t>
            </a:r>
            <a:r>
              <a:rPr lang="en-GB" sz="1200" b="1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-F expression in cell lines and in relation to oestrogen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A) PCR products generated using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cDN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from cycling MCF-7 cells, using a forward primer in exon 1d and a reverse primer in exon 16. Major products are full-length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, but a number of smaller products are evident including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also lacking exon 4, 5 and part of 6 (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D;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Table 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). These products were cloned and sequence verified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B) Schematic showing detection tools for quantitative RT-PCR (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PCR) for CIZ1 replication domain (CIZ1-RD) and CIZ1-F. 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C) Quantitative RT-PCR using full-length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plasmids as template, showing selective amplification of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template by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detection tools shown in (B). Full-length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plasmid is not detected by the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primer-probe set (CT-value &gt; 40), whereas both plasmids are amplified by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RD primer sets. Graphs show expression levels relative to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RD ± SEM for three technical replicates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D) Left: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transcript in a set of cancer-derived cell lines (dark grey) and three non-cancer comparators (light grey). Relative quantities (RQ) are shown ± SEM for three technical replicates, expressed relative to MCF-10A normal breast epithelial cells which is set at 1. All data is normalised to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ACTB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YP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Right: mean value of the normal cell lines compared to the mean value of the cancer cell lines ± SEM. Material from cell lines (EJ, H727,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HeL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HFL1, SBC2, SBC5) other than those indicated in the Methods section was available from previous studies.</a:t>
            </a:r>
            <a:r>
              <a:rPr lang="en-GB" sz="1200" baseline="30000" dirty="0">
                <a:latin typeface="Times New Roman" pitchFamily="18" charset="0"/>
                <a:cs typeface="Times New Roman" pitchFamily="18" charset="0"/>
              </a:rPr>
              <a:t>1, 2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dditional RNA from breast cancer cell lines BT474, SKBR3 and MDA-MB-231 was kindly provided by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Dr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William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Brackenbury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Department of Biology, The University of York, York, United Kingdom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E) Effect of oestrogen (1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for 16 h) on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-F and full-length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IZ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mRNA expression levels in MCF-7 cells. Oestrogen-responsive genes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CCND1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MYC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re shown for comparison. Mean levels (± SEM) from three technical replicates are shown relative to the levels in untreated cells. All primer and probe sequences are in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Table 2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nl-NL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nl-NL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8472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46</TotalTime>
  <Words>490</Words>
  <Application>Microsoft Office PowerPoint</Application>
  <PresentationFormat>A4 Paper (210x297 mm)</PresentationFormat>
  <Paragraphs>1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ian Swarts</dc:creator>
  <cp:lastModifiedBy>Dorian2018</cp:lastModifiedBy>
  <cp:revision>835</cp:revision>
  <cp:lastPrinted>2016-03-07T16:44:20Z</cp:lastPrinted>
  <dcterms:created xsi:type="dcterms:W3CDTF">2014-11-24T16:22:39Z</dcterms:created>
  <dcterms:modified xsi:type="dcterms:W3CDTF">2018-06-20T09:20:15Z</dcterms:modified>
</cp:coreProperties>
</file>